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1" d="100"/>
          <a:sy n="91" d="100"/>
        </p:scale>
        <p:origin x="351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0B68716-8797-A01F-C67D-7718BE3DD28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A487AC46-DA94-AACB-DEF7-5E745922B97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3E848D7-F581-AE19-2F4A-B6AD5E9D23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73A07-5482-4144-9F60-F76E22FC184B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C4D34FA-B417-4000-CF09-9C30088206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0FAD6D0-2709-6892-77DC-56E7A72E9D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3ECC3-11BC-4589-B5AB-DAF5B35B5B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62980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3CBF276-7F19-8CC8-2F9B-4F8B9DC312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BB0A1A5-5F08-C237-99EE-9700A6C5257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7FBB54B-94A5-9398-8F4F-90AF9BA291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73A07-5482-4144-9F60-F76E22FC184B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AFC7E11-213D-6BD5-7EEC-E8A095509A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87FF74E-CFFC-C6BA-3DC8-CFF8FFF276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3ECC3-11BC-4589-B5AB-DAF5B35B5B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31493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5BDB9A7-8AD6-F251-D771-69E267F804C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D2C01D2-A168-7E47-CB1C-468300BC46C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77049F1-2667-60BA-95D8-9FE8377AC6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73A07-5482-4144-9F60-F76E22FC184B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1600B1A-F01E-7FE6-1F5A-C360A838AD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87289B4-732C-BD71-3A93-CC6CB974C5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3ECC3-11BC-4589-B5AB-DAF5B35B5B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61386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E340AA7-8F1B-989C-D0F6-4B61AACB5A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E13ADA0-734E-FAC6-5AEB-8D71880CCB4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8307402-66B9-9B55-FBFE-4BA9687230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73A07-5482-4144-9F60-F76E22FC184B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A1515F6-67AD-5079-01E0-9E0E49E18E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1FF6924-F567-45D6-2B2C-83C8B1C0AA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3ECC3-11BC-4589-B5AB-DAF5B35B5B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917245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067D8BA-A647-3237-B9CF-7E8E318658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3766DEB-C92A-CB66-9589-F270E216F9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644AD61-A971-19DA-15C1-478A52DA35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73A07-5482-4144-9F60-F76E22FC184B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1CF050D-02AD-0EC2-43DB-414289EB08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8FAD41E-FC4A-7A69-D9A7-4EBDFEDBDC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3ECC3-11BC-4589-B5AB-DAF5B35B5B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07603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81FC1C5-EBE0-1187-0F9F-4B440C0913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6915DE6-0070-A9EC-06D4-E8BE8D0F60F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43006F4-872B-0B61-6E77-87B8EF9AF5C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EF7EEFE-F79D-8F51-56CD-D35B886EF9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73A07-5482-4144-9F60-F76E22FC184B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BD6536A-11B9-7F53-022F-9439EC40AB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8A42D9E-2808-7633-F0C5-13C0EFC0BB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3ECC3-11BC-4589-B5AB-DAF5B35B5B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52876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946C722-D12C-7F67-942C-6230CF1B06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0AAF58E-2E34-88B6-DEF6-B154241CD0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061BCB2-A1EC-37FE-B9E1-C88ACD65BC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665DE037-E2ED-848C-684C-1F3F0AFEEAF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C03EF788-4669-9789-0BC1-66F8E69F9CB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8DBD5A69-5137-E6F6-F64D-DBCAD3F19E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73A07-5482-4144-9F60-F76E22FC184B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B31F1D85-57CB-FB20-730C-8B0B2417FB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28C0B48C-A472-99FA-A151-20B8895046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3ECC3-11BC-4589-B5AB-DAF5B35B5B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96335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A97A6FA-65CC-F663-ECBB-4B1C6B14D8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2BA7F5F0-1D83-C839-1207-64D35B4A93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73A07-5482-4144-9F60-F76E22FC184B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E679E45D-D412-CF59-6882-A8E8BE7F24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643D6210-FCB3-E822-CC56-8C9233940E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3ECC3-11BC-4589-B5AB-DAF5B35B5B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60225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78726B50-0C3E-7194-6EC4-9C10E618AB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73A07-5482-4144-9F60-F76E22FC184B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CB9C9E12-1E38-E9A1-3DBB-9DA7B9133D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D0136E74-02F1-5987-F854-01066A928E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3ECC3-11BC-4589-B5AB-DAF5B35B5B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78690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9A73B7F-F940-9A2A-F3F0-826D43AA25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11192BD-BC73-5E40-A556-A5402DA0F21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7F32818-44CD-CC84-6636-B02E512CB78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D622D06-6A32-E78E-B25D-4057C16708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73A07-5482-4144-9F60-F76E22FC184B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EB3A85E-8A9D-4E3D-593D-5DE74BD9FE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EFA4931-20D8-D0D9-90F2-07E204353A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3ECC3-11BC-4589-B5AB-DAF5B35B5B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74851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56C2A8B-1424-ED80-BCF9-D7F74A3A91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564B7F8-3376-A296-702B-A37E784DFB7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E64F646-C1BE-BBDA-0F8F-FCEDD90AE57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0F94377-71DF-9FDF-54B6-5C744B4837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73A07-5482-4144-9F60-F76E22FC184B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D09F90E-1F6A-D6FA-5ACD-6865C0A60B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5277D0F-2657-3473-9BCD-3C5C7584FF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3ECC3-11BC-4589-B5AB-DAF5B35B5B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840693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CDA1383D-C718-E1E7-FB61-1E9BDBEDD1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8BBF8C8-3EAE-10D5-59CA-8FFAD6F83E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60E520F-B153-EE55-8B86-3B4591D5B14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F73A07-5482-4144-9F60-F76E22FC184B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E375B68-F5FD-6811-9A8C-E49C7DF7D5C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D73126B-5178-1059-0D2D-28401409610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23ECC3-11BC-4589-B5AB-DAF5B35B5B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42361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>
            <a:extLst>
              <a:ext uri="{FF2B5EF4-FFF2-40B4-BE49-F238E27FC236}">
                <a16:creationId xmlns:a16="http://schemas.microsoft.com/office/drawing/2014/main" id="{FB099815-1AB2-E6E5-0CDF-033E992DBEC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4698108"/>
              </p:ext>
            </p:extLst>
          </p:nvPr>
        </p:nvGraphicFramePr>
        <p:xfrm>
          <a:off x="2133362" y="164990"/>
          <a:ext cx="7925276" cy="6304122"/>
        </p:xfrm>
        <a:graphic>
          <a:graphicData uri="http://schemas.openxmlformats.org/drawingml/2006/table">
            <a:tbl>
              <a:tblPr firstRow="1" firstCol="1" bandRow="1"/>
              <a:tblGrid>
                <a:gridCol w="2540404">
                  <a:extLst>
                    <a:ext uri="{9D8B030D-6E8A-4147-A177-3AD203B41FA5}">
                      <a16:colId xmlns:a16="http://schemas.microsoft.com/office/drawing/2014/main" val="2361985584"/>
                    </a:ext>
                  </a:extLst>
                </a:gridCol>
                <a:gridCol w="2786598">
                  <a:extLst>
                    <a:ext uri="{9D8B030D-6E8A-4147-A177-3AD203B41FA5}">
                      <a16:colId xmlns:a16="http://schemas.microsoft.com/office/drawing/2014/main" val="1877064292"/>
                    </a:ext>
                  </a:extLst>
                </a:gridCol>
                <a:gridCol w="2598274">
                  <a:extLst>
                    <a:ext uri="{9D8B030D-6E8A-4147-A177-3AD203B41FA5}">
                      <a16:colId xmlns:a16="http://schemas.microsoft.com/office/drawing/2014/main" val="1465177394"/>
                    </a:ext>
                  </a:extLst>
                </a:gridCol>
              </a:tblGrid>
              <a:tr h="35022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Strain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Species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Source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39870439"/>
                  </a:ext>
                </a:extLst>
              </a:tr>
              <a:tr h="35022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C600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i="1" kern="100" dirty="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E. coli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aboratory strain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97015615"/>
                  </a:ext>
                </a:extLst>
              </a:tr>
              <a:tr h="35022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DP01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i="1" kern="100" dirty="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E. coli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Human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59575369"/>
                  </a:ext>
                </a:extLst>
              </a:tr>
              <a:tr h="35022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Y7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i="1" kern="100" dirty="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E. coli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Duck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36266188"/>
                  </a:ext>
                </a:extLst>
              </a:tr>
              <a:tr h="35022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6-52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i="1" kern="100" dirty="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E. coli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Swine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64265559"/>
                  </a:ext>
                </a:extLst>
              </a:tr>
              <a:tr h="35022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WF81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i="1" kern="100" dirty="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E. coli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Duck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47470630"/>
                  </a:ext>
                </a:extLst>
              </a:tr>
              <a:tr h="35022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ATCC14028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i="1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Salmonella</a:t>
                      </a: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 Typhimurium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aboratory strain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12366551"/>
                  </a:ext>
                </a:extLst>
              </a:tr>
              <a:tr h="35022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SS70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i="1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Salmonella</a:t>
                      </a:r>
                      <a:r>
                        <a:rPr lang="en-US" sz="12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 Typhimurium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Duck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15054953"/>
                  </a:ext>
                </a:extLst>
              </a:tr>
              <a:tr h="35022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WF62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i="1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Salmonella </a:t>
                      </a:r>
                      <a:r>
                        <a:rPr lang="en-US" sz="12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Typhimurium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Duck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0592064"/>
                  </a:ext>
                </a:extLst>
              </a:tr>
              <a:tr h="35022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XJ48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i="1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Salmonella </a:t>
                      </a: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Typhimurium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Duck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07394147"/>
                  </a:ext>
                </a:extLst>
              </a:tr>
              <a:tr h="35022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6E270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i="1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Salmonella </a:t>
                      </a: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Indiana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Human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72671589"/>
                  </a:ext>
                </a:extLst>
              </a:tr>
              <a:tr h="35022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Y21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i="1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Salmonella </a:t>
                      </a: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Indiana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Duck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92681081"/>
                  </a:ext>
                </a:extLst>
              </a:tr>
              <a:tr h="35022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XZ9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i="1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Salmonella </a:t>
                      </a: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Indiana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Duck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92401918"/>
                  </a:ext>
                </a:extLst>
              </a:tr>
              <a:tr h="35022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ATCC700603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i="1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K. pneumoniae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aboratory strain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10964589"/>
                  </a:ext>
                </a:extLst>
              </a:tr>
              <a:tr h="35022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1QH35K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i="1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K. pneumoniae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Migratory bird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05267277"/>
                  </a:ext>
                </a:extLst>
              </a:tr>
              <a:tr h="35022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1QH46H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i="1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K. pneumoniae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Migratory bird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5192888"/>
                  </a:ext>
                </a:extLst>
              </a:tr>
              <a:tr h="35022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523-1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i="1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K. pneumoniae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Chicken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74865480"/>
                  </a:ext>
                </a:extLst>
              </a:tr>
              <a:tr h="35022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523-56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i="1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K. pneumoniae</a:t>
                      </a:r>
                      <a:endParaRPr lang="zh-CN" sz="1200" kern="10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Chicken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0421" marR="6042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7292448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86415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86</Words>
  <Application>Microsoft Office PowerPoint</Application>
  <PresentationFormat>宽屏</PresentationFormat>
  <Paragraphs>5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Kaidi Liu</dc:creator>
  <cp:lastModifiedBy>Kaidi Liu</cp:lastModifiedBy>
  <cp:revision>2</cp:revision>
  <dcterms:created xsi:type="dcterms:W3CDTF">2024-02-22T07:51:05Z</dcterms:created>
  <dcterms:modified xsi:type="dcterms:W3CDTF">2024-02-22T08:02:26Z</dcterms:modified>
</cp:coreProperties>
</file>